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51450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F93BC5-925A-4751-BA69-A09266AE0D5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6172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2973240"/>
            <a:ext cx="6172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A0A02F-22B6-419F-B821-6FCE963545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2973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2973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3107E6-25AB-4F07-B52C-84AD4EA8D3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1200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1200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2973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2973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2973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1EE04F-F528-4B51-A6B8-E008D1EB9E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1200240"/>
            <a:ext cx="6172200" cy="3394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DD0105-F389-4129-9853-2D20295F1F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617220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A707FD-F18A-4C7F-9970-06F48AADA4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301176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1200240"/>
            <a:ext cx="301176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2F6BF-6A5E-4E0F-A45D-919103F035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F8B3DF-3CD6-49A0-B246-A5CC382042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206280"/>
            <a:ext cx="6172200" cy="3976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472F7A-0F19-4C1A-B73A-4E09278F58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1200240"/>
            <a:ext cx="301176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2973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DCC3D5-63E8-494A-B5BB-866AFFD70D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301176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2973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859B76-54B9-497C-8FFC-EFC74ED978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2973240"/>
            <a:ext cx="6172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BC3490-6B9A-451C-B4CD-CDA4DE7899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1200240"/>
            <a:ext cx="617220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55600" indent="-25560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1" marL="555480" indent="-21240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2" marL="855720" indent="-16992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3" marL="1198440" indent="-16956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4" marL="1541520" indent="-16992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5" marL="1541520" indent="-16992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6" marL="1541520" indent="-16992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4766760"/>
            <a:ext cx="1600200" cy="2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4766760"/>
            <a:ext cx="2171520" cy="2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4766760"/>
            <a:ext cx="1600200" cy="2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86A27D-A7FC-4D07-950B-1006721BFAF0}" type="slidenum">
              <a:rPr b="0" lang="en-US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Oval 3"/>
          <p:cNvSpPr/>
          <p:nvPr/>
        </p:nvSpPr>
        <p:spPr>
          <a:xfrm>
            <a:off x="4741920" y="1349280"/>
            <a:ext cx="311040" cy="31140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Oval 4"/>
          <p:cNvSpPr/>
          <p:nvPr/>
        </p:nvSpPr>
        <p:spPr>
          <a:xfrm>
            <a:off x="2641680" y="1352520"/>
            <a:ext cx="309600" cy="31104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Oval 7"/>
          <p:cNvSpPr/>
          <p:nvPr/>
        </p:nvSpPr>
        <p:spPr>
          <a:xfrm>
            <a:off x="1704960" y="1352520"/>
            <a:ext cx="311040" cy="31104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Oval 8"/>
          <p:cNvSpPr/>
          <p:nvPr/>
        </p:nvSpPr>
        <p:spPr>
          <a:xfrm>
            <a:off x="4838760" y="3257640"/>
            <a:ext cx="119160" cy="11880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Oval 9"/>
          <p:cNvSpPr/>
          <p:nvPr/>
        </p:nvSpPr>
        <p:spPr>
          <a:xfrm>
            <a:off x="4851360" y="4056120"/>
            <a:ext cx="92160" cy="9216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Straight Connector 11"/>
          <p:cNvSpPr/>
          <p:nvPr/>
        </p:nvSpPr>
        <p:spPr>
          <a:xfrm>
            <a:off x="1941480" y="2422440"/>
            <a:ext cx="28004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Straight Connector 13"/>
          <p:cNvSpPr/>
          <p:nvPr/>
        </p:nvSpPr>
        <p:spPr>
          <a:xfrm>
            <a:off x="2795760" y="1663560"/>
            <a:ext cx="0" cy="685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Straight Connector 15"/>
          <p:cNvSpPr/>
          <p:nvPr/>
        </p:nvSpPr>
        <p:spPr>
          <a:xfrm>
            <a:off x="4897440" y="2577960"/>
            <a:ext cx="0" cy="14781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6"/>
          <p:cNvSpPr/>
          <p:nvPr/>
        </p:nvSpPr>
        <p:spPr>
          <a:xfrm>
            <a:off x="1330200" y="1095480"/>
            <a:ext cx="1072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Choleraesui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7"/>
          <p:cNvSpPr/>
          <p:nvPr/>
        </p:nvSpPr>
        <p:spPr>
          <a:xfrm>
            <a:off x="1388520" y="2577960"/>
            <a:ext cx="95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Newport-II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8"/>
          <p:cNvSpPr/>
          <p:nvPr/>
        </p:nvSpPr>
        <p:spPr>
          <a:xfrm>
            <a:off x="2337120" y="2571840"/>
            <a:ext cx="91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Newport-I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9"/>
          <p:cNvSpPr/>
          <p:nvPr/>
        </p:nvSpPr>
        <p:spPr>
          <a:xfrm>
            <a:off x="3273480" y="2567160"/>
            <a:ext cx="1064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yphimuriu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20"/>
          <p:cNvSpPr/>
          <p:nvPr/>
        </p:nvSpPr>
        <p:spPr>
          <a:xfrm>
            <a:off x="929880" y="355680"/>
            <a:ext cx="57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ig. S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21"/>
          <p:cNvSpPr/>
          <p:nvPr/>
        </p:nvSpPr>
        <p:spPr>
          <a:xfrm>
            <a:off x="5016240" y="2295360"/>
            <a:ext cx="88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nteritidi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22"/>
          <p:cNvSpPr/>
          <p:nvPr/>
        </p:nvSpPr>
        <p:spPr>
          <a:xfrm>
            <a:off x="4551840" y="1095480"/>
            <a:ext cx="691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Dubl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23"/>
          <p:cNvSpPr/>
          <p:nvPr/>
        </p:nvSpPr>
        <p:spPr>
          <a:xfrm>
            <a:off x="2474280" y="1095480"/>
            <a:ext cx="64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yph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4"/>
          <p:cNvSpPr/>
          <p:nvPr/>
        </p:nvSpPr>
        <p:spPr>
          <a:xfrm>
            <a:off x="4953960" y="3189240"/>
            <a:ext cx="83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ulloru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5"/>
          <p:cNvSpPr/>
          <p:nvPr/>
        </p:nvSpPr>
        <p:spPr>
          <a:xfrm>
            <a:off x="4952880" y="3975120"/>
            <a:ext cx="94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allinaru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Oval 1"/>
          <p:cNvSpPr/>
          <p:nvPr/>
        </p:nvSpPr>
        <p:spPr>
          <a:xfrm>
            <a:off x="3649680" y="2266920"/>
            <a:ext cx="311040" cy="311040"/>
          </a:xfrm>
          <a:prstGeom prst="ellipse">
            <a:avLst/>
          </a:prstGeom>
          <a:solidFill>
            <a:srgbClr val="ff0000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Oval 2"/>
          <p:cNvSpPr/>
          <p:nvPr/>
        </p:nvSpPr>
        <p:spPr>
          <a:xfrm>
            <a:off x="4741920" y="2266920"/>
            <a:ext cx="311040" cy="311040"/>
          </a:xfrm>
          <a:prstGeom prst="ellipse">
            <a:avLst/>
          </a:prstGeom>
          <a:solidFill>
            <a:srgbClr val="ff0000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Oval 6"/>
          <p:cNvSpPr/>
          <p:nvPr/>
        </p:nvSpPr>
        <p:spPr>
          <a:xfrm>
            <a:off x="1778040" y="2340000"/>
            <a:ext cx="163440" cy="165240"/>
          </a:xfrm>
          <a:prstGeom prst="ellipse">
            <a:avLst/>
          </a:prstGeom>
          <a:solidFill>
            <a:srgbClr val="ff0000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Oval 5"/>
          <p:cNvSpPr/>
          <p:nvPr/>
        </p:nvSpPr>
        <p:spPr>
          <a:xfrm>
            <a:off x="2722680" y="2349360"/>
            <a:ext cx="147600" cy="146160"/>
          </a:xfrm>
          <a:prstGeom prst="ellipse">
            <a:avLst/>
          </a:prstGeom>
          <a:solidFill>
            <a:srgbClr val="ff0000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Straight Connector 13"/>
          <p:cNvSpPr/>
          <p:nvPr/>
        </p:nvSpPr>
        <p:spPr>
          <a:xfrm>
            <a:off x="1857240" y="1654200"/>
            <a:ext cx="0" cy="685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Straight Connector 13"/>
          <p:cNvSpPr/>
          <p:nvPr/>
        </p:nvSpPr>
        <p:spPr>
          <a:xfrm>
            <a:off x="4897440" y="1581120"/>
            <a:ext cx="0" cy="685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5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11-03T14:37:30Z</dcterms:created>
  <dc:creator>Thomas Kaufmann</dc:creator>
  <dc:description/>
  <dc:language>en-US</dc:language>
  <cp:lastModifiedBy>Alexey Rakov</cp:lastModifiedBy>
  <cp:lastPrinted>2018-10-15T22:13:39Z</cp:lastPrinted>
  <dcterms:modified xsi:type="dcterms:W3CDTF">2019-03-06T15:34:14Z</dcterms:modified>
  <cp:revision>233</cp:revision>
  <dc:subject/>
  <dc:title>PowerPoint Presentation</dc:title>
</cp:coreProperties>
</file>